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90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62"/>
    <p:restoredTop sz="94705"/>
  </p:normalViewPr>
  <p:slideViewPr>
    <p:cSldViewPr snapToGrid="0" snapToObjects="1">
      <p:cViewPr varScale="1">
        <p:scale>
          <a:sx n="97" d="100"/>
          <a:sy n="97" d="100"/>
        </p:scale>
        <p:origin x="232" y="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Anshu\AppData\Local\Packages\Microsoft.Office.Desktop_8wekyb3d8bbwe\LocalCache\Roaming\Microsoft\Excel\2020_05_14%20UCSD%20Data%20base_v3%20(version%201).xlsb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AHI Changes'!$M$3:$M$12</cx:f>
        <cx:lvl ptCount="10" formatCode="_-* #,##0.0_-;\-* #,##0.0_-;_-* &quot;-&quot;??_-;_-@_-">
          <cx:pt idx="0">6.0643185300000004</cx:pt>
          <cx:pt idx="1">6.082949309</cx:pt>
          <cx:pt idx="2">25.060240960000002</cx:pt>
          <cx:pt idx="3">56.94915254</cx:pt>
          <cx:pt idx="4">9.1458607099999991</cx:pt>
          <cx:pt idx="5">9.9095022620000002</cx:pt>
          <cx:pt idx="6">7.3295454549999999</cx:pt>
          <cx:pt idx="7">17.41324921</cx:pt>
          <cx:pt idx="8">39.34747145</cx:pt>
          <cx:pt idx="9">19.70025449177778</cx:pt>
        </cx:lvl>
      </cx:numDim>
    </cx:data>
    <cx:data id="1">
      <cx:numDim type="val">
        <cx:f>'AHI Changes'!$N$3:$N$12</cx:f>
        <cx:lvl ptCount="10" formatCode="_-* #,##0.0_-;\-* #,##0.0_-;_-* &quot;-&quot;??_-;_-@_-">
          <cx:pt idx="0">6.0534124629999999</cx:pt>
          <cx:pt idx="1">5.546218487</cx:pt>
          <cx:pt idx="2">5.9238363889999999</cx:pt>
          <cx:pt idx="3">16.423841060000001</cx:pt>
          <cx:pt idx="4">7.4261603379999999</cx:pt>
          <cx:pt idx="5">7.3295454549999999</cx:pt>
          <cx:pt idx="6">3.6594663280000002</cx:pt>
          <cx:pt idx="7">6.4972375690000002</cx:pt>
          <cx:pt idx="8">16.84981685</cx:pt>
          <cx:pt idx="9">8.4121705487777785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/>
            </a:pPr>
            <a:r>
              <a:rPr lang="en-US" sz="1400" b="0" i="0" u="none" strike="noStrike" baseline="0" dirty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/>
              </a:rPr>
              <a:t>Change in AHI in Responders</a:t>
            </a:r>
          </a:p>
          <a:p>
            <a:pPr algn="ctr" rtl="0">
              <a:defRPr/>
            </a:pPr>
            <a:r>
              <a:rPr lang="en-US" sz="1400" b="0" i="0" u="none" strike="noStrike" baseline="0" dirty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/>
              </a:rPr>
              <a:t>N= 9</a:t>
            </a:r>
          </a:p>
        </cx:rich>
      </cx:tx>
    </cx:title>
    <cx:plotArea>
      <cx:plotAreaRegion>
        <cx:series layoutId="boxWhisker" uniqueId="{95803462-D7F8-46F4-A369-3B7ECFE6F7E6}">
          <cx:tx>
            <cx:txData>
              <cx:f>'AHI Changes'!$M$2</cx:f>
              <cx:v>AHI Before</cx:v>
            </cx:txData>
          </cx:tx>
          <cx:dataId val="0"/>
          <cx:layoutPr>
            <cx:visibility meanLine="1" meanMarker="1" nonoutliers="0" outliers="1"/>
            <cx:statistics quartileMethod="exclusive"/>
          </cx:layoutPr>
        </cx:series>
        <cx:series layoutId="boxWhisker" uniqueId="{03F9F2A6-DCFB-4007-85C3-E57BCAEF91D0}">
          <cx:tx>
            <cx:txData>
              <cx:f>'AHI Changes'!$N$2</cx:f>
              <cx:v>AHI After</cx:v>
            </cx:txData>
          </cx:tx>
          <cx:dataId val="1"/>
          <cx:layoutPr>
            <cx:visibility meanLine="1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/>
                </a:pPr>
                <a:r>
                  <a:rPr lang="en-US" sz="1600" b="0" i="0" u="none" strike="noStrike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Calibri" panose="020F0502020204030204"/>
                  </a:rPr>
                  <a:t>AHI</a:t>
                </a:r>
                <a:endParaRPr lang="en-US" sz="900" b="0" i="0" u="none" strike="noStrike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latin typeface="Calibri" panose="020F0502020204030204"/>
                </a:endParaRPr>
              </a:p>
            </cx:rich>
          </cx:tx>
        </cx:title>
        <cx:majorGridlines/>
        <cx:tickLabels/>
      </cx:axis>
    </cx:plotArea>
    <cx:legend pos="b" align="ctr" overlay="0"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600" baseline="0"/>
          </a:pPr>
          <a:endParaRPr lang="en-US" sz="1600" b="0" i="0" u="none" strike="noStrike" baseline="0">
            <a:solidFill>
              <a:sysClr val="windowText" lastClr="000000">
                <a:lumMod val="65000"/>
                <a:lumOff val="35000"/>
              </a:sysClr>
            </a:solidFill>
            <a:latin typeface="Calibri" panose="020F0502020204030204"/>
          </a:endParaRPr>
        </a:p>
      </cx:txPr>
    </cx:legend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7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3D4945-B1CE-C042-8858-C84C1C2E1ED3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6555D1-D914-7F44-9DDA-FE85FB9C5F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899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erformance score not available – supplemental tab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D0B02F-732F-584D-8B3C-D5D7DB3CEE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212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4: Responder analysis using </a:t>
            </a:r>
            <a:r>
              <a:rPr lang="en-US" dirty="0" err="1"/>
              <a:t>Wilcoxan</a:t>
            </a:r>
            <a:r>
              <a:rPr lang="en-US" dirty="0"/>
              <a:t> rank sum test for those with an AHI&gt;5. </a:t>
            </a:r>
          </a:p>
          <a:p>
            <a:endParaRPr lang="en-US" dirty="0"/>
          </a:p>
          <a:p>
            <a:r>
              <a:rPr lang="en-US" dirty="0"/>
              <a:t>Are these</a:t>
            </a:r>
            <a:r>
              <a:rPr lang="en-US" baseline="0" dirty="0"/>
              <a:t> two figures showing the same thing?  </a:t>
            </a:r>
            <a:r>
              <a:rPr lang="en-US" baseline="0"/>
              <a:t>Would only use 1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D0B02F-732F-584D-8B3C-D5D7DB3CEEA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237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02B71-7734-A545-9811-427DA5D7AD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736AC2-8364-A74D-8B5D-C6E3734371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08C134-A764-DA42-AB89-ECC7DE691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C1CF1D-50DB-F84B-9D1B-9582F0C50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F7289D-DBA6-414C-92A7-38F880C82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622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2676D-7FD5-4E46-BC3A-0FAE9B7AF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62E316-BBEE-A04D-BED6-474BB8EA76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88488B-D7A2-1746-932A-93BAB5208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5E945A-8B8E-D14B-9386-CC089C418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347A44-4C65-1044-8387-B2F5DBBC7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412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2B518B-CCB9-D548-83DF-5003138EDB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9AEFA4-5BE1-7C44-A383-7002DBE000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7EE89-C607-4C44-B255-65E2DE557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40F491-7B76-6E46-8481-71F8FB5D6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CF3071-FDB7-7440-8023-56B10B2CC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84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F98F6-D803-5341-941D-0FE408D95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DCF12-170B-2047-8F54-33017F6F67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7DB537-FB92-E14B-80F2-C4FF964FB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AF1AAA-17CD-5940-9FC8-4C110EBC2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41854D-CA96-8B41-9A0B-54EDBD18C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606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3FD3AB-0857-0D4F-B47F-D5DFD7A58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C5866A-D15D-C949-8CDF-9D59319D68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130EA7-4C26-CD4D-8F52-36AE8DF42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46E61-7C5C-CE4B-8324-7CAD6C76A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F1F0C5-8978-FA46-9AAB-B123253D4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503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23B15D-4651-1C48-AFE5-B893B636C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6C8647-E8A3-B848-BE41-0B68F8B22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CE45BB-A9F4-6842-8D95-306243A1C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A617CC-DB0B-F845-9FE7-BF69DDC81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AD450-ED74-BB4C-91F5-AF566FB2E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7E3B23-8712-8047-A393-6DF20A3E6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769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FF57DF-C83B-4E4D-B71F-F2A7816E1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E391B0-EB93-4C4D-9648-93CC34ED7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AF7AA3-C958-AE4B-B4A0-82A2020A76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D7CA98-648A-C646-8CAB-7075AA5EFF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CE9F8A-16DA-EE4E-BB66-F953D0CD13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FFD390-B9BC-9346-ACA1-F2EEDC033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9D9020-4AEC-0E40-8050-D360A8F39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DD280E-40BC-D748-B689-922FCD0EF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976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0E252-ECA1-A748-BA5F-7850C51D77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759893-388F-E946-87C9-9C78CC187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D6F953-27AE-2E44-9DFC-CA4607ACF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A241BE-5A39-9C48-AC59-D8EFB5D1C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697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CD52DD-3B53-E643-B9CA-1EC09F061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B80A81-F009-EA4F-A8D8-D1CAECF8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A45471-8BCB-DC4A-9B04-843B3A614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8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81DBCC-8DC2-DB49-9C63-74922C00E4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317FAD-53B9-FA45-AA92-37C1B9A2BC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B2C619-185D-D34D-BA19-3FA44887F3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090F52-7873-7F44-AA06-17C795A82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3E2360-FCF6-BD4C-B10C-9D5E5E7D7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C98961-5A83-1945-90A4-C839EE255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333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40776-C25F-6347-958A-1FAA17B07D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030491-D013-BF46-BFD4-3A336B2385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CEB922-749C-5348-B4FA-27417BB372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AB3E11-422D-3049-BFB6-FB7797AA2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58A81A-3A50-8B47-87EF-B52246630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A24A17-85D1-DD48-834D-58A8D4F3F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52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E49273-2870-8C45-AC03-692FFD87E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82FDDD-D910-B74E-A966-FA58A08AB0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D8413-AF89-364D-B4D6-C828651DD3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0EECD-63F9-9447-B0CA-ED7B2A81E338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87D05A-8BBD-204E-B0BB-67E92A75EE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F66355-DD29-D94A-8A3B-E324F6C7C1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8A56E-AB0C-2C4E-8C87-5A7062DEB8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108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E9F19B7-6BF4-FE4C-89BE-5B832CC16C70}"/>
              </a:ext>
            </a:extLst>
          </p:cNvPr>
          <p:cNvGraphicFramePr>
            <a:graphicFrameLocks noGrp="1"/>
          </p:cNvGraphicFramePr>
          <p:nvPr/>
        </p:nvGraphicFramePr>
        <p:xfrm>
          <a:off x="3313216" y="2221325"/>
          <a:ext cx="5522809" cy="356819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11184">
                  <a:extLst>
                    <a:ext uri="{9D8B030D-6E8A-4147-A177-3AD203B41FA5}">
                      <a16:colId xmlns:a16="http://schemas.microsoft.com/office/drawing/2014/main" val="830173529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4025205975"/>
                    </a:ext>
                  </a:extLst>
                </a:gridCol>
                <a:gridCol w="1384935">
                  <a:extLst>
                    <a:ext uri="{9D8B030D-6E8A-4147-A177-3AD203B41FA5}">
                      <a16:colId xmlns:a16="http://schemas.microsoft.com/office/drawing/2014/main" val="3373181911"/>
                    </a:ext>
                  </a:extLst>
                </a:gridCol>
                <a:gridCol w="1342390">
                  <a:extLst>
                    <a:ext uri="{9D8B030D-6E8A-4147-A177-3AD203B41FA5}">
                      <a16:colId xmlns:a16="http://schemas.microsoft.com/office/drawing/2014/main" val="27934791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VT variab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e-treatment 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median + IQ Range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ost-treatment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median + IQ Range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-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40098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ean Reaction time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17 (290.6-353.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313 (291-33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3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516873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edian Reaction time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7 (277-332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1 (276-32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9519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/RT (m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2 (3.0-3.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3 (3-3.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3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764766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lowest 10% 1/RT (+/- Min RT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2.4 (2.2-2.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4 </a:t>
                      </a:r>
                      <a:r>
                        <a:rPr lang="en-US" sz="1200" kern="1200">
                          <a:effectLst/>
                        </a:rPr>
                        <a:t>(2.2-2.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773791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astest 10% RT (+/- Max RT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237 (224-25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42 </a:t>
                      </a:r>
                      <a:r>
                        <a:rPr lang="en-US" sz="1200" kern="1200">
                          <a:effectLst/>
                        </a:rPr>
                        <a:t>(229-26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669006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umber of lapses &gt;500m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3 (1-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1 (0.5-3.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800025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umber of false start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1 (0-2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0 (0-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04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06092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umber of lapses and false start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4 (2-6.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 (1.3-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=0.0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10346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erformance sco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684272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8632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298335AB-32D2-4A52-B7E4-80A736EC818F}"/>
              </a:ext>
            </a:extLst>
          </p:cNvPr>
          <p:cNvGrpSpPr/>
          <p:nvPr/>
        </p:nvGrpSpPr>
        <p:grpSpPr>
          <a:xfrm>
            <a:off x="5113685" y="1953730"/>
            <a:ext cx="5219702" cy="4211639"/>
            <a:chOff x="5932836" y="2139747"/>
            <a:chExt cx="5219702" cy="421163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C234C27-2066-452B-A425-67781CEC35C4}"/>
                </a:ext>
              </a:extLst>
            </p:cNvPr>
            <p:cNvSpPr txBox="1"/>
            <p:nvPr/>
          </p:nvSpPr>
          <p:spPr>
            <a:xfrm>
              <a:off x="7729672" y="5582347"/>
              <a:ext cx="593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19.7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FA03AEC-F98B-4E40-8F9C-3A27D3F0948A}"/>
                </a:ext>
              </a:extLst>
            </p:cNvPr>
            <p:cNvSpPr txBox="1"/>
            <p:nvPr/>
          </p:nvSpPr>
          <p:spPr>
            <a:xfrm>
              <a:off x="9566414" y="5582347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8.4</a:t>
              </a:r>
            </a:p>
          </p:txBody>
        </p:sp>
        <mc:AlternateContent xmlns:mc="http://schemas.openxmlformats.org/markup-compatibility/2006">
          <mc:Choice xmlns:cx1="http://schemas.microsoft.com/office/drawing/2015/9/8/chartex" Requires="cx1">
            <p:graphicFrame>
              <p:nvGraphicFramePr>
                <p:cNvPr id="19" name="Chart 18">
                  <a:extLst>
                    <a:ext uri="{FF2B5EF4-FFF2-40B4-BE49-F238E27FC236}">
                      <a16:creationId xmlns:a16="http://schemas.microsoft.com/office/drawing/2014/main" id="{0EBC8663-E996-43DB-BD03-570DFF3CBDD8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3654145928"/>
                    </p:ext>
                  </p:extLst>
                </p:nvPr>
              </p:nvGraphicFramePr>
              <p:xfrm>
                <a:off x="5932836" y="2139747"/>
                <a:ext cx="5219702" cy="4211639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3"/>
                </a:graphicData>
              </a:graphic>
            </p:graphicFrame>
          </mc:Choice>
          <mc:Fallback>
            <p:pic>
              <p:nvPicPr>
                <p:cNvPr id="19" name="Chart 18">
                  <a:extLst>
                    <a:ext uri="{FF2B5EF4-FFF2-40B4-BE49-F238E27FC236}">
                      <a16:creationId xmlns:a16="http://schemas.microsoft.com/office/drawing/2014/main" id="{0EBC8663-E996-43DB-BD03-570DFF3CBDD8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5113685" y="1953730"/>
                  <a:ext cx="5219702" cy="4211639"/>
                </a:xfrm>
                <a:prstGeom prst="rect">
                  <a:avLst/>
                </a:prstGeom>
              </p:spPr>
            </p:pic>
          </mc:Fallback>
        </mc:AlternateContent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D1D24C8-B106-9C44-AC32-A1E90A11AF22}"/>
              </a:ext>
            </a:extLst>
          </p:cNvPr>
          <p:cNvSpPr txBox="1"/>
          <p:nvPr/>
        </p:nvSpPr>
        <p:spPr>
          <a:xfrm>
            <a:off x="9052063" y="3096111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=0.001</a:t>
            </a:r>
          </a:p>
        </p:txBody>
      </p:sp>
      <p:sp>
        <p:nvSpPr>
          <p:cNvPr id="9" name="Title 8">
            <a:extLst>
              <a:ext uri="{FF2B5EF4-FFF2-40B4-BE49-F238E27FC236}">
                <a16:creationId xmlns:a16="http://schemas.microsoft.com/office/drawing/2014/main" id="{B5FBC6EA-308F-CA4B-9E83-3FD0CA3A8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ponder analysis in those with AHI reduction &gt;50%</a:t>
            </a:r>
          </a:p>
        </p:txBody>
      </p:sp>
    </p:spTree>
    <p:extLst>
      <p:ext uri="{BB962C8B-B14F-4D97-AF65-F5344CB8AC3E}">
        <p14:creationId xmlns:p14="http://schemas.microsoft.com/office/powerpoint/2010/main" val="1602775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27</Words>
  <Application>Microsoft Macintosh PowerPoint</Application>
  <PresentationFormat>Widescreen</PresentationFormat>
  <Paragraphs>55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Responder analysis in those with AHI reduction &gt;50%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kes, Brandon</dc:creator>
  <cp:lastModifiedBy>Nokes, Brandon</cp:lastModifiedBy>
  <cp:revision>3</cp:revision>
  <dcterms:created xsi:type="dcterms:W3CDTF">2021-06-29T19:50:35Z</dcterms:created>
  <dcterms:modified xsi:type="dcterms:W3CDTF">2022-06-10T22:02:01Z</dcterms:modified>
</cp:coreProperties>
</file>